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434" y="1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607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44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6092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16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279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052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1273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0497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1791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7088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379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EF9FC-2C97-4785-81C7-4ADBFEF1EEB6}" type="datetimeFigureOut">
              <a:rPr lang="en-GB" smtClean="0"/>
              <a:t>19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853027-84BA-4B54-935B-AC574EF56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668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043608" y="5949280"/>
            <a:ext cx="734481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udy site and sampling scheme used for this study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aerial view of the study showing the two transects (T140 and T210) at the study site at Fox Hill in West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ngelly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estern Australia;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s looking upslope on T140 and downslope on T210; and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diagram demonstrating the sampl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int location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two main transects T140 and T210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728" y="0"/>
            <a:ext cx="4315968" cy="5992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6622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35696" y="5949280"/>
            <a:ext cx="48242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 pH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, an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 across each of the transects at Fox Hill;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e orientation of the pH kriging plot in relation to the landscape.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7" y="156090"/>
            <a:ext cx="4933820" cy="57931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15787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1052737"/>
            <a:ext cx="6480000" cy="4127351"/>
          </a:xfrm>
          <a:prstGeom prst="rect">
            <a:avLst/>
          </a:prstGeom>
          <a:noFill/>
        </p:spPr>
      </p:pic>
      <p:sp>
        <p:nvSpPr>
          <p:cNvPr id="2" name="Rectangle 1"/>
          <p:cNvSpPr/>
          <p:nvPr/>
        </p:nvSpPr>
        <p:spPr>
          <a:xfrm>
            <a:off x="1187622" y="5299978"/>
            <a:ext cx="64800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ordinate analysi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 based on unweight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Fra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anc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ing differences in the bacterial composition of soil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unities collected from different sampl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ations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9572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797" y="116632"/>
            <a:ext cx="7289774" cy="5751237"/>
          </a:xfrm>
          <a:prstGeom prst="rect">
            <a:avLst/>
          </a:prstGeom>
          <a:noFill/>
        </p:spPr>
      </p:pic>
      <p:sp>
        <p:nvSpPr>
          <p:cNvPr id="2" name="Rectangle 1"/>
          <p:cNvSpPr/>
          <p:nvPr/>
        </p:nvSpPr>
        <p:spPr>
          <a:xfrm>
            <a:off x="705797" y="5867869"/>
            <a:ext cx="728977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ilies with significantly higher mean relative abundances in the upper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, 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tom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lateau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 - F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tions of T140.</a:t>
            </a:r>
          </a:p>
        </p:txBody>
      </p:sp>
    </p:spTree>
    <p:extLst>
      <p:ext uri="{BB962C8B-B14F-4D97-AF65-F5344CB8AC3E}">
        <p14:creationId xmlns:p14="http://schemas.microsoft.com/office/powerpoint/2010/main" val="17454371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0720" y="1320244"/>
            <a:ext cx="7167724" cy="2562239"/>
          </a:xfrm>
          <a:prstGeom prst="rect">
            <a:avLst/>
          </a:prstGeom>
          <a:noFill/>
        </p:spPr>
      </p:pic>
      <p:sp>
        <p:nvSpPr>
          <p:cNvPr id="2" name="Rectangle 1"/>
          <p:cNvSpPr/>
          <p:nvPr/>
        </p:nvSpPr>
        <p:spPr>
          <a:xfrm>
            <a:off x="1259632" y="3933056"/>
            <a:ext cx="69847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RUS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edicted Kyoto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yclopedi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Genes and Genome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EGG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ie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ly associated with soil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: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itrous-oxide reductase and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nitrous oxidase accessory protein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51978" y="105273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932040" y="105273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3939187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220</Words>
  <Application>Microsoft Office PowerPoint</Application>
  <PresentationFormat>On-screen Show (4:3)</PresentationFormat>
  <Paragraphs>7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ra O'Brien</dc:creator>
  <cp:lastModifiedBy>Flora O'Brien</cp:lastModifiedBy>
  <cp:revision>6</cp:revision>
  <dcterms:created xsi:type="dcterms:W3CDTF">2019-05-29T01:04:34Z</dcterms:created>
  <dcterms:modified xsi:type="dcterms:W3CDTF">2019-06-19T15:05:14Z</dcterms:modified>
</cp:coreProperties>
</file>